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673850" cy="12344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65F61-B699-4A92-8F03-2CC3A174D3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8640" y="3286080"/>
            <a:ext cx="575784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8640" y="7377480"/>
            <a:ext cx="575784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59D689-DA75-4EBC-BDB5-E154DA4C5B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8640" y="3286080"/>
            <a:ext cx="280980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09200" y="3286080"/>
            <a:ext cx="280980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8640" y="7377480"/>
            <a:ext cx="280980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09200" y="7377480"/>
            <a:ext cx="280980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A982BC-DF2A-4915-8525-831B29B513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8640" y="3286080"/>
            <a:ext cx="185364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05520" y="3286080"/>
            <a:ext cx="185364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352040" y="3286080"/>
            <a:ext cx="185364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8640" y="7377480"/>
            <a:ext cx="185364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05520" y="7377480"/>
            <a:ext cx="185364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352040" y="7377480"/>
            <a:ext cx="185364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36967D-DF96-437A-B615-F41B704077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8640" y="3286080"/>
            <a:ext cx="5757840" cy="7832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26"/>
              </a:spcBef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49B602-1025-4829-8B89-7C8A765BD4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8640" y="3286080"/>
            <a:ext cx="5757840" cy="7832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56569-398F-41DC-A97B-D16BCA4E2C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8640" y="3286080"/>
            <a:ext cx="2809800" cy="7832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09200" y="3286080"/>
            <a:ext cx="2809800" cy="7832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A010E5-7094-4DE2-A2EA-2E58A11B2B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4C01E-E1FC-4246-80A7-744AEB98C6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8640" y="657000"/>
            <a:ext cx="5757840" cy="11059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26"/>
              </a:spcBef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059CBA-7E88-43CC-B5E8-97242751C3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8640" y="3286080"/>
            <a:ext cx="280980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09200" y="3286080"/>
            <a:ext cx="2809800" cy="7832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8640" y="7377480"/>
            <a:ext cx="280980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957D1E-68C2-4E39-B5D4-2A90914942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8640" y="3286080"/>
            <a:ext cx="2809800" cy="7832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09200" y="3286080"/>
            <a:ext cx="280980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09200" y="7377480"/>
            <a:ext cx="280980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7E18C-3DD9-41C9-81BB-6E9C89F97F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8640" y="3286080"/>
            <a:ext cx="280980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09200" y="3286080"/>
            <a:ext cx="280980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8640" y="7377480"/>
            <a:ext cx="5757840" cy="373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26"/>
              </a:spcBef>
              <a:buNone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49C28-A91A-4EE4-9947-CA7B7F985D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8640" y="657000"/>
            <a:ext cx="57578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2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8640" y="3286080"/>
            <a:ext cx="5757840" cy="7832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66680" indent="-1666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500040" indent="-1666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2" marL="833400" indent="-1666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3" marL="1166760" indent="-1666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4" marL="1501920" indent="-1666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5" marL="1501920" indent="-1666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6" marL="1501920" indent="-1666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666720"/>
                <a:tab algn="l" pos="1333440"/>
                <a:tab algn="l" pos="2000160"/>
                <a:tab algn="l" pos="2666880"/>
                <a:tab algn="l" pos="3333600"/>
                <a:tab algn="l" pos="4000680"/>
                <a:tab algn="l" pos="4667400"/>
                <a:tab algn="l" pos="5334120"/>
                <a:tab algn="l" pos="6000840"/>
                <a:tab algn="l" pos="6667560"/>
                <a:tab algn="l" pos="7334280"/>
                <a:tab algn="l" pos="8001000"/>
                <a:tab algn="l" pos="8667720"/>
                <a:tab algn="l" pos="9334440"/>
                <a:tab algn="l" pos="10001160"/>
                <a:tab algn="l" pos="1066788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8640" y="11440800"/>
            <a:ext cx="1501920" cy="65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11120" y="11440800"/>
            <a:ext cx="2252520" cy="65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714560" y="11440800"/>
            <a:ext cx="1501560" cy="65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AE923D2-4354-4772-A437-DC13F9ABFEA8}" type="slidenum">
              <a:rPr b="0" lang="en-US" sz="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rcRect l="17899" t="39390" r="58384" b="20694"/>
          <a:stretch/>
        </p:blipFill>
        <p:spPr>
          <a:xfrm>
            <a:off x="390600" y="649440"/>
            <a:ext cx="2730600" cy="2581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rcRect l="17899" t="22717" r="58384" b="36358"/>
          <a:stretch/>
        </p:blipFill>
        <p:spPr>
          <a:xfrm>
            <a:off x="3813120" y="630360"/>
            <a:ext cx="2730600" cy="26478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3"/>
          <a:srcRect l="17755" t="42928" r="58348" b="16654"/>
          <a:stretch/>
        </p:blipFill>
        <p:spPr>
          <a:xfrm>
            <a:off x="379440" y="3321000"/>
            <a:ext cx="2751120" cy="26146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" descr=""/>
          <p:cNvPicPr/>
          <p:nvPr/>
        </p:nvPicPr>
        <p:blipFill>
          <a:blip r:embed="rId4"/>
          <a:srcRect l="17274" t="48327" r="58652" b="11019"/>
          <a:stretch/>
        </p:blipFill>
        <p:spPr>
          <a:xfrm>
            <a:off x="3718080" y="3330720"/>
            <a:ext cx="2770200" cy="26305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7" descr=""/>
          <p:cNvPicPr/>
          <p:nvPr/>
        </p:nvPicPr>
        <p:blipFill>
          <a:blip r:embed="rId5"/>
          <a:srcRect l="17921" t="45325" r="58184" b="14946"/>
          <a:stretch/>
        </p:blipFill>
        <p:spPr>
          <a:xfrm>
            <a:off x="368280" y="5959440"/>
            <a:ext cx="2751120" cy="25700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8" descr=""/>
          <p:cNvPicPr/>
          <p:nvPr/>
        </p:nvPicPr>
        <p:blipFill>
          <a:blip r:embed="rId6"/>
          <a:srcRect l="17285" t="40837" r="58926" b="17146"/>
          <a:stretch/>
        </p:blipFill>
        <p:spPr>
          <a:xfrm>
            <a:off x="3722760" y="5902200"/>
            <a:ext cx="2738520" cy="2719440"/>
          </a:xfrm>
          <a:prstGeom prst="rect">
            <a:avLst/>
          </a:prstGeom>
          <a:ln w="0">
            <a:noFill/>
          </a:ln>
        </p:spPr>
      </p:pic>
      <p:sp>
        <p:nvSpPr>
          <p:cNvPr id="47" name="TextBox 10"/>
          <p:cNvSpPr/>
          <p:nvPr/>
        </p:nvSpPr>
        <p:spPr>
          <a:xfrm>
            <a:off x="157320" y="8494560"/>
            <a:ext cx="6405480" cy="379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 Gating strategy for ES2 ALD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hi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umor initiating cells (TIC). Cells were treated with the specific aldehyde dehydrogenase (ALDH) inhibitor diethylaminobenzaldehyde (DEAB), as a negative control to set the gate for ALD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h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cells, considered as TIC. (A) Negative control ES2 control. (B) ALD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h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ES2 control cells. (C) Negative control, ES2 PD-L1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lo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clone 1. (D) ALD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h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ES2 PD-L1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lo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clone 1 cells. (E) Negative control, ES2 PD-L1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lo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clone 2. (F) ALD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h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ES2 PD-L1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lo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clone 2 cells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51120" y="614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2"/>
          <p:cNvSpPr/>
          <p:nvPr/>
        </p:nvSpPr>
        <p:spPr>
          <a:xfrm>
            <a:off x="55080" y="33051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3465000" y="3314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4"/>
          <p:cNvSpPr/>
          <p:nvPr/>
        </p:nvSpPr>
        <p:spPr>
          <a:xfrm>
            <a:off x="51840" y="59342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5"/>
          <p:cNvSpPr/>
          <p:nvPr/>
        </p:nvSpPr>
        <p:spPr>
          <a:xfrm>
            <a:off x="3450240" y="592452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6"/>
          <p:cNvSpPr/>
          <p:nvPr/>
        </p:nvSpPr>
        <p:spPr>
          <a:xfrm>
            <a:off x="3465000" y="614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18T15:53:32Z</dcterms:created>
  <dc:creator>Owner</dc:creator>
  <dc:description/>
  <dc:language>en-US</dc:language>
  <cp:lastModifiedBy>l.latha</cp:lastModifiedBy>
  <dcterms:modified xsi:type="dcterms:W3CDTF">2016-12-21T10:32:52Z</dcterms:modified>
  <cp:revision>3</cp:revision>
  <dc:subject/>
  <dc:title>PowerPoint Presentation</dc:title>
</cp:coreProperties>
</file>